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4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9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Documents\Write-ups\_Manuscripts\ABA%20suppresses%20WGE%20elicitation%20of%20glyceollins\Extras\Fig3\Dehydration%20Norflurazon%2031%20H63%20Seedlings%206day%20pH5%208%20June%2027%202017%20Fig%203A%20Supplement%20Exp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:$F$6</c:f>
                <c:numCache>
                  <c:formatCode>General</c:formatCode>
                  <c:ptCount val="4"/>
                  <c:pt idx="0">
                    <c:v>0.68121776804616341</c:v>
                  </c:pt>
                  <c:pt idx="1">
                    <c:v>0.31336536620749211</c:v>
                  </c:pt>
                  <c:pt idx="2">
                    <c:v>9.7239602719298213E-2</c:v>
                  </c:pt>
                  <c:pt idx="3">
                    <c:v>0.8886068823616694</c:v>
                  </c:pt>
                </c:numCache>
              </c:numRef>
            </c:plus>
            <c:minus>
              <c:numRef>
                <c:f>Sheet1!$C$6:$F$6</c:f>
                <c:numCache>
                  <c:formatCode>General</c:formatCode>
                  <c:ptCount val="4"/>
                  <c:pt idx="0">
                    <c:v>0.68121776804616341</c:v>
                  </c:pt>
                  <c:pt idx="1">
                    <c:v>0.31336536620749211</c:v>
                  </c:pt>
                  <c:pt idx="2">
                    <c:v>9.7239602719298213E-2</c:v>
                  </c:pt>
                  <c:pt idx="3">
                    <c:v>0.888606882361669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3:$F$3</c:f>
              <c:strCache>
                <c:ptCount val="4"/>
                <c:pt idx="0">
                  <c:v>Glyceollin I</c:v>
                </c:pt>
                <c:pt idx="1">
                  <c:v>Glyceollin II</c:v>
                </c:pt>
                <c:pt idx="2">
                  <c:v>Glyceollin III</c:v>
                </c:pt>
                <c:pt idx="3">
                  <c:v>Total glyceollins</c:v>
                </c:pt>
              </c:strCache>
            </c:strRef>
          </c:cat>
          <c:val>
            <c:numRef>
              <c:f>Sheet1!$C$5:$F$5</c:f>
              <c:numCache>
                <c:formatCode>General</c:formatCode>
                <c:ptCount val="4"/>
                <c:pt idx="0">
                  <c:v>5.4341382933333335</c:v>
                </c:pt>
                <c:pt idx="1">
                  <c:v>2.0062555199999998</c:v>
                </c:pt>
                <c:pt idx="2">
                  <c:v>3.9882414399999999</c:v>
                </c:pt>
                <c:pt idx="3">
                  <c:v>12.43963525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5E-4C01-9621-32CD8AFCFEA4}"/>
            </c:ext>
          </c:extLst>
        </c:ser>
        <c:ser>
          <c:idx val="1"/>
          <c:order val="1"/>
          <c:tx>
            <c:strRef>
              <c:f>Sheet1!$B$11</c:f>
              <c:strCache>
                <c:ptCount val="1"/>
                <c:pt idx="0">
                  <c:v>Dehydration</c:v>
                </c:pt>
              </c:strCache>
            </c:strRef>
          </c:tx>
          <c:spPr>
            <a:solidFill>
              <a:schemeClr val="accent2"/>
            </a:solidFill>
            <a:ln w="1270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2:$F$12</c:f>
                <c:numCache>
                  <c:formatCode>General</c:formatCode>
                  <c:ptCount val="4"/>
                  <c:pt idx="0">
                    <c:v>0.28726312519206337</c:v>
                  </c:pt>
                  <c:pt idx="1">
                    <c:v>0.17952772235884848</c:v>
                  </c:pt>
                  <c:pt idx="2">
                    <c:v>0.63053253927847008</c:v>
                  </c:pt>
                  <c:pt idx="3">
                    <c:v>0.96550677635138415</c:v>
                  </c:pt>
                </c:numCache>
              </c:numRef>
            </c:plus>
            <c:minus>
              <c:numRef>
                <c:f>Sheet1!$C$12:$F$12</c:f>
                <c:numCache>
                  <c:formatCode>General</c:formatCode>
                  <c:ptCount val="4"/>
                  <c:pt idx="0">
                    <c:v>0.28726312519206337</c:v>
                  </c:pt>
                  <c:pt idx="1">
                    <c:v>0.17952772235884848</c:v>
                  </c:pt>
                  <c:pt idx="2">
                    <c:v>0.63053253927847008</c:v>
                  </c:pt>
                  <c:pt idx="3">
                    <c:v>0.9655067763513841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11:$F$11</c:f>
              <c:numCache>
                <c:formatCode>General</c:formatCode>
                <c:ptCount val="4"/>
                <c:pt idx="0">
                  <c:v>0.68972533333333352</c:v>
                </c:pt>
                <c:pt idx="1">
                  <c:v>0.97953568000000013</c:v>
                </c:pt>
                <c:pt idx="2">
                  <c:v>4.0142083200000007</c:v>
                </c:pt>
                <c:pt idx="3">
                  <c:v>6.694469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5E-4C01-9621-32CD8AFCFEA4}"/>
            </c:ext>
          </c:extLst>
        </c:ser>
        <c:ser>
          <c:idx val="2"/>
          <c:order val="2"/>
          <c:tx>
            <c:strRef>
              <c:f>Sheet1!$B$17</c:f>
              <c:strCache>
                <c:ptCount val="1"/>
                <c:pt idx="0">
                  <c:v>Dehydration with Norflurazon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8:$F$18</c:f>
                <c:numCache>
                  <c:formatCode>General</c:formatCode>
                  <c:ptCount val="4"/>
                  <c:pt idx="0">
                    <c:v>0.35069969506307369</c:v>
                  </c:pt>
                  <c:pt idx="1">
                    <c:v>0.31631842081042316</c:v>
                  </c:pt>
                  <c:pt idx="2">
                    <c:v>2.0699901187736249</c:v>
                  </c:pt>
                  <c:pt idx="3">
                    <c:v>2.5135824261483379</c:v>
                  </c:pt>
                </c:numCache>
              </c:numRef>
            </c:plus>
            <c:minus>
              <c:numRef>
                <c:f>Sheet1!$C$18:$F$18</c:f>
                <c:numCache>
                  <c:formatCode>General</c:formatCode>
                  <c:ptCount val="4"/>
                  <c:pt idx="0">
                    <c:v>0.35069969506307369</c:v>
                  </c:pt>
                  <c:pt idx="1">
                    <c:v>0.31631842081042316</c:v>
                  </c:pt>
                  <c:pt idx="2">
                    <c:v>2.0699901187736249</c:v>
                  </c:pt>
                  <c:pt idx="3">
                    <c:v>2.513582426148337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C$17:$F$17</c:f>
              <c:numCache>
                <c:formatCode>General</c:formatCode>
                <c:ptCount val="4"/>
                <c:pt idx="0">
                  <c:v>2.2468880000000002</c:v>
                </c:pt>
                <c:pt idx="1">
                  <c:v>2.6263720000000004</c:v>
                </c:pt>
                <c:pt idx="2">
                  <c:v>10.127262666666669</c:v>
                </c:pt>
                <c:pt idx="3">
                  <c:v>15.011522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35E-4C01-9621-32CD8AFCFE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2756552"/>
        <c:axId val="513421280"/>
      </c:barChart>
      <c:catAx>
        <c:axId val="512756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3421280"/>
        <c:crosses val="autoZero"/>
        <c:auto val="1"/>
        <c:lblAlgn val="ctr"/>
        <c:lblOffset val="100"/>
        <c:noMultiLvlLbl val="0"/>
      </c:catAx>
      <c:valAx>
        <c:axId val="5134212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Amounts (µg gt</a:t>
                </a:r>
                <a:r>
                  <a:rPr lang="en-US" sz="800" b="0" i="0" baseline="30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US" sz="8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800" b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27565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4521697287839019"/>
          <c:y val="7.5808544765237684E-2"/>
          <c:w val="0.41867191601049869"/>
          <c:h val="0.17708661417322835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06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814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62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781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648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52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5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438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60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09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481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8B720-7251-4A04-9F9D-E47C4FB0561F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B1C91-C5C7-483A-B735-387B86DF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157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B0039E2-A392-4408-BB7F-E0209F3706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4064975"/>
              </p:ext>
            </p:extLst>
          </p:nvPr>
        </p:nvGraphicFramePr>
        <p:xfrm>
          <a:off x="1447800" y="255563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矩形 2">
            <a:extLst>
              <a:ext uri="{FF2B5EF4-FFF2-40B4-BE49-F238E27FC236}">
                <a16:creationId xmlns:a16="http://schemas.microsoft.com/office/drawing/2014/main" id="{B483325C-1B36-490D-B6BC-25C24FBFC82A}"/>
              </a:ext>
            </a:extLst>
          </p:cNvPr>
          <p:cNvSpPr/>
          <p:nvPr/>
        </p:nvSpPr>
        <p:spPr>
          <a:xfrm>
            <a:off x="1652954" y="5343616"/>
            <a:ext cx="433753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8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zh-CN" sz="8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eat of experiment in Figure 3C. Glyceollin amounts in </a:t>
            </a:r>
            <a:r>
              <a:rPr lang="en-US" altLang="zh-CN" sz="8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osoy</a:t>
            </a:r>
            <a:r>
              <a:rPr lang="en-US" altLang="zh-CN" sz="8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3 soybean seedlings after 6 d dehydration with or without </a:t>
            </a:r>
            <a:r>
              <a:rPr lang="en-US" altLang="zh-CN" sz="8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flurazone</a:t>
            </a:r>
            <a:r>
              <a:rPr lang="en-US" altLang="zh-CN" sz="8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measured by UPLC-PDA. </a:t>
            </a:r>
            <a:r>
              <a:rPr lang="en-US" altLang="zh-CN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fferent letters show significant differences by single factor ANOVA, Tukey post hoc test, P &lt; 0.05, </a:t>
            </a:r>
            <a:r>
              <a:rPr lang="el-GR" altLang="zh-CN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 = 0.05. </a:t>
            </a:r>
            <a:r>
              <a:rPr lang="en-US" altLang="zh-CN" sz="8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= standard error (SE) for three independent biological duplicates (n ≥ 3). For a list of statistical values, see Supplementary Table S4.</a:t>
            </a:r>
            <a:endParaRPr lang="zh-CN" altLang="zh-CN" sz="8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842464F-7E23-424A-9137-E933178EAAF2}"/>
              </a:ext>
            </a:extLst>
          </p:cNvPr>
          <p:cNvSpPr txBox="1"/>
          <p:nvPr/>
        </p:nvSpPr>
        <p:spPr>
          <a:xfrm>
            <a:off x="5467739" y="2755641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D25740-44E6-40A2-A6A1-B6D9E8BBD203}"/>
              </a:ext>
            </a:extLst>
          </p:cNvPr>
          <p:cNvSpPr txBox="1"/>
          <p:nvPr/>
        </p:nvSpPr>
        <p:spPr>
          <a:xfrm>
            <a:off x="5072743" y="3243944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B8E7BA-E9DC-4435-8028-84B135B5910B}"/>
              </a:ext>
            </a:extLst>
          </p:cNvPr>
          <p:cNvSpPr txBox="1"/>
          <p:nvPr/>
        </p:nvSpPr>
        <p:spPr>
          <a:xfrm>
            <a:off x="5274907" y="3900197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3FA2BB-AAE2-4A8D-A5B8-C9294E5F16CF}"/>
              </a:ext>
            </a:extLst>
          </p:cNvPr>
          <p:cNvSpPr txBox="1"/>
          <p:nvPr/>
        </p:nvSpPr>
        <p:spPr>
          <a:xfrm>
            <a:off x="4512907" y="3355911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7758D1-C300-4ADF-8F74-65F0784ECA3E}"/>
              </a:ext>
            </a:extLst>
          </p:cNvPr>
          <p:cNvSpPr txBox="1"/>
          <p:nvPr/>
        </p:nvSpPr>
        <p:spPr>
          <a:xfrm>
            <a:off x="4295193" y="4220548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BA8EA0-BF66-4246-9852-A3D1D8C5BF0C}"/>
              </a:ext>
            </a:extLst>
          </p:cNvPr>
          <p:cNvSpPr txBox="1"/>
          <p:nvPr/>
        </p:nvSpPr>
        <p:spPr>
          <a:xfrm>
            <a:off x="4105470" y="4298303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6205A16-5237-4821-ADDD-534A9CF0388A}"/>
              </a:ext>
            </a:extLst>
          </p:cNvPr>
          <p:cNvSpPr txBox="1"/>
          <p:nvPr/>
        </p:nvSpPr>
        <p:spPr>
          <a:xfrm>
            <a:off x="3539413" y="4447592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7C8A31-3696-4561-908F-13B8DA5F4E86}"/>
              </a:ext>
            </a:extLst>
          </p:cNvPr>
          <p:cNvSpPr txBox="1"/>
          <p:nvPr/>
        </p:nvSpPr>
        <p:spPr>
          <a:xfrm>
            <a:off x="3327919" y="4683968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5BDF570-126C-4BD9-A1F5-37CFFF7126CC}"/>
              </a:ext>
            </a:extLst>
          </p:cNvPr>
          <p:cNvSpPr txBox="1"/>
          <p:nvPr/>
        </p:nvSpPr>
        <p:spPr>
          <a:xfrm>
            <a:off x="3119533" y="4519128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B76AFC-BB2E-4B8A-92DB-744CC7D9D7AE}"/>
              </a:ext>
            </a:extLst>
          </p:cNvPr>
          <p:cNvSpPr txBox="1"/>
          <p:nvPr/>
        </p:nvSpPr>
        <p:spPr>
          <a:xfrm>
            <a:off x="2139819" y="4086810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136CD5-1DE7-400E-A39A-3B18B1BA97AC}"/>
              </a:ext>
            </a:extLst>
          </p:cNvPr>
          <p:cNvSpPr txBox="1"/>
          <p:nvPr/>
        </p:nvSpPr>
        <p:spPr>
          <a:xfrm>
            <a:off x="2553476" y="4475586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C49775F-3AF4-4898-AA65-5739BCFE33A9}"/>
              </a:ext>
            </a:extLst>
          </p:cNvPr>
          <p:cNvSpPr txBox="1"/>
          <p:nvPr/>
        </p:nvSpPr>
        <p:spPr>
          <a:xfrm>
            <a:off x="2348202" y="4680859"/>
            <a:ext cx="223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13360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00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Nik Kovinich</cp:lastModifiedBy>
  <cp:revision>7</cp:revision>
  <dcterms:created xsi:type="dcterms:W3CDTF">2023-08-22T23:40:46Z</dcterms:created>
  <dcterms:modified xsi:type="dcterms:W3CDTF">2024-09-18T14:22:52Z</dcterms:modified>
</cp:coreProperties>
</file>